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009" autoAdjust="0"/>
    <p:restoredTop sz="96327"/>
  </p:normalViewPr>
  <p:slideViewPr>
    <p:cSldViewPr snapToGrid="0">
      <p:cViewPr varScale="1">
        <p:scale>
          <a:sx n="123" d="100"/>
          <a:sy n="123" d="100"/>
        </p:scale>
        <p:origin x="22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aheem Seedat" userId="a3b850f0-9731-4f1d-8829-b416e6c6e2f6" providerId="ADAL" clId="{05453257-1A0F-4E4F-8447-A7B8308C453A}"/>
    <pc:docChg chg="custSel modSld">
      <pc:chgData name="Faheem Seedat" userId="a3b850f0-9731-4f1d-8829-b416e6c6e2f6" providerId="ADAL" clId="{05453257-1A0F-4E4F-8447-A7B8308C453A}" dt="2024-09-18T15:55:21.764" v="40" actId="5736"/>
      <pc:docMkLst>
        <pc:docMk/>
      </pc:docMkLst>
      <pc:sldChg chg="addSp delSp modSp mod">
        <pc:chgData name="Faheem Seedat" userId="a3b850f0-9731-4f1d-8829-b416e6c6e2f6" providerId="ADAL" clId="{05453257-1A0F-4E4F-8447-A7B8308C453A}" dt="2024-09-18T15:55:21.764" v="40" actId="5736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92E820CF-56C2-6D40-A05D-4F7CBA30B860}"/>
    <pc:docChg chg="modSld">
      <pc:chgData name="Faheem Seedat" userId="a3b850f0-9731-4f1d-8829-b416e6c6e2f6" providerId="ADAL" clId="{92E820CF-56C2-6D40-A05D-4F7CBA30B860}" dt="2024-12-20T17:54:47.033" v="125" actId="20577"/>
      <pc:docMkLst>
        <pc:docMk/>
      </pc:docMkLst>
      <pc:sldChg chg="modSp mod">
        <pc:chgData name="Faheem Seedat" userId="a3b850f0-9731-4f1d-8829-b416e6c6e2f6" providerId="ADAL" clId="{92E820CF-56C2-6D40-A05D-4F7CBA30B860}" dt="2024-12-20T17:54:47.033" v="125" actId="20577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B448B931-5CFD-4C6D-819D-14768E9F6DEF}"/>
    <pc:docChg chg="modSld">
      <pc:chgData name="Faheem Seedat" userId="a3b850f0-9731-4f1d-8829-b416e6c6e2f6" providerId="ADAL" clId="{B448B931-5CFD-4C6D-819D-14768E9F6DEF}" dt="2024-08-20T13:02:58.677" v="26" actId="20577"/>
      <pc:docMkLst>
        <pc:docMk/>
      </pc:docMkLst>
      <pc:sldChg chg="modSp mod">
        <pc:chgData name="Faheem Seedat" userId="a3b850f0-9731-4f1d-8829-b416e6c6e2f6" providerId="ADAL" clId="{B448B931-5CFD-4C6D-819D-14768E9F6DEF}" dt="2024-08-20T13:02:58.677" v="26" actId="20577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046CB876-C65B-354D-9CEB-4118FEA6F599}"/>
    <pc:docChg chg="modSld">
      <pc:chgData name="Faheem Seedat" userId="a3b850f0-9731-4f1d-8829-b416e6c6e2f6" providerId="ADAL" clId="{046CB876-C65B-354D-9CEB-4118FEA6F599}" dt="2025-03-12T20:51:45.114" v="1" actId="20577"/>
      <pc:docMkLst>
        <pc:docMk/>
      </pc:docMkLst>
      <pc:sldChg chg="modSp mod">
        <pc:chgData name="Faheem Seedat" userId="a3b850f0-9731-4f1d-8829-b416e6c6e2f6" providerId="ADAL" clId="{046CB876-C65B-354D-9CEB-4118FEA6F599}" dt="2025-03-12T20:51:45.114" v="1" actId="20577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8685C627-F741-B64A-A176-3F2D07E1109F}"/>
    <pc:docChg chg="undo custSel modSld">
      <pc:chgData name="Faheem Seedat" userId="a3b850f0-9731-4f1d-8829-b416e6c6e2f6" providerId="ADAL" clId="{8685C627-F741-B64A-A176-3F2D07E1109F}" dt="2024-08-17T10:03:43.603" v="27" actId="20577"/>
      <pc:docMkLst>
        <pc:docMk/>
      </pc:docMkLst>
      <pc:sldChg chg="addSp delSp modSp mod">
        <pc:chgData name="Faheem Seedat" userId="a3b850f0-9731-4f1d-8829-b416e6c6e2f6" providerId="ADAL" clId="{8685C627-F741-B64A-A176-3F2D07E1109F}" dt="2024-08-17T10:03:43.603" v="27" actId="20577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C8D6E6DB-D6DF-9F4F-9192-82E154B8A7CA}"/>
    <pc:docChg chg="modSld">
      <pc:chgData name="Faheem Seedat" userId="a3b850f0-9731-4f1d-8829-b416e6c6e2f6" providerId="ADAL" clId="{C8D6E6DB-D6DF-9F4F-9192-82E154B8A7CA}" dt="2025-05-07T20:09:11.895" v="2" actId="1076"/>
      <pc:docMkLst>
        <pc:docMk/>
      </pc:docMkLst>
      <pc:sldChg chg="modSp mod">
        <pc:chgData name="Faheem Seedat" userId="a3b850f0-9731-4f1d-8829-b416e6c6e2f6" providerId="ADAL" clId="{C8D6E6DB-D6DF-9F4F-9192-82E154B8A7CA}" dt="2025-05-07T20:09:11.895" v="2" actId="1076"/>
        <pc:sldMkLst>
          <pc:docMk/>
          <pc:sldMk cId="109857222" sldId="256"/>
        </pc:sldMkLst>
        <pc:graphicFrameChg chg="mod modGraphic">
          <ac:chgData name="Faheem Seedat" userId="a3b850f0-9731-4f1d-8829-b416e6c6e2f6" providerId="ADAL" clId="{C8D6E6DB-D6DF-9F4F-9192-82E154B8A7CA}" dt="2025-05-07T20:09:11.895" v="2" actId="1076"/>
          <ac:graphicFrameMkLst>
            <pc:docMk/>
            <pc:sldMk cId="109857222" sldId="256"/>
            <ac:graphicFrameMk id="3" creationId="{9FC23B5E-FEB3-2E25-D355-5A19F825E536}"/>
          </ac:graphicFrameMkLst>
        </pc:graphicFrameChg>
      </pc:sldChg>
    </pc:docChg>
  </pc:docChgLst>
  <pc:docChgLst>
    <pc:chgData name="Faheem Seedat" userId="a3b850f0-9731-4f1d-8829-b416e6c6e2f6" providerId="ADAL" clId="{7F43A798-D988-1F42-BC85-4E3866B26429}"/>
    <pc:docChg chg="modSld">
      <pc:chgData name="Faheem Seedat" userId="a3b850f0-9731-4f1d-8829-b416e6c6e2f6" providerId="ADAL" clId="{7F43A798-D988-1F42-BC85-4E3866B26429}" dt="2025-06-21T07:01:11.949" v="32" actId="20577"/>
      <pc:docMkLst>
        <pc:docMk/>
      </pc:docMkLst>
      <pc:sldChg chg="modSp mod">
        <pc:chgData name="Faheem Seedat" userId="a3b850f0-9731-4f1d-8829-b416e6c6e2f6" providerId="ADAL" clId="{7F43A798-D988-1F42-BC85-4E3866B26429}" dt="2025-06-21T07:01:11.949" v="32" actId="20577"/>
        <pc:sldMkLst>
          <pc:docMk/>
          <pc:sldMk cId="109857222" sldId="256"/>
        </pc:sldMkLst>
        <pc:graphicFrameChg chg="modGraphic">
          <ac:chgData name="Faheem Seedat" userId="a3b850f0-9731-4f1d-8829-b416e6c6e2f6" providerId="ADAL" clId="{7F43A798-D988-1F42-BC85-4E3866B26429}" dt="2025-06-21T07:01:11.949" v="32" actId="20577"/>
          <ac:graphicFrameMkLst>
            <pc:docMk/>
            <pc:sldMk cId="109857222" sldId="256"/>
            <ac:graphicFrameMk id="3" creationId="{9FC23B5E-FEB3-2E25-D355-5A19F825E536}"/>
          </ac:graphicFrameMkLst>
        </pc:graphicFrameChg>
      </pc:sldChg>
    </pc:docChg>
  </pc:docChgLst>
  <pc:docChgLst>
    <pc:chgData name="Faheem Seedat" userId="a3b850f0-9731-4f1d-8829-b416e6c6e2f6" providerId="ADAL" clId="{A7BB7F14-5E94-4CBB-B248-F6C4EE1FE4EA}"/>
    <pc:docChg chg="undo custSel modSld">
      <pc:chgData name="Faheem Seedat" userId="a3b850f0-9731-4f1d-8829-b416e6c6e2f6" providerId="ADAL" clId="{A7BB7F14-5E94-4CBB-B248-F6C4EE1FE4EA}" dt="2024-07-22T14:43:50.578" v="12" actId="122"/>
      <pc:docMkLst>
        <pc:docMk/>
      </pc:docMkLst>
      <pc:sldChg chg="addSp delSp modSp mod">
        <pc:chgData name="Faheem Seedat" userId="a3b850f0-9731-4f1d-8829-b416e6c6e2f6" providerId="ADAL" clId="{A7BB7F14-5E94-4CBB-B248-F6C4EE1FE4EA}" dt="2024-07-22T14:43:50.578" v="12" actId="122"/>
        <pc:sldMkLst>
          <pc:docMk/>
          <pc:sldMk cId="109857222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FC23B5E-FEB3-2E25-D355-5A19F825E5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9457611"/>
              </p:ext>
            </p:extLst>
          </p:nvPr>
        </p:nvGraphicFramePr>
        <p:xfrm>
          <a:off x="67733" y="423960"/>
          <a:ext cx="12056534" cy="5737169"/>
        </p:xfrm>
        <a:graphic>
          <a:graphicData uri="http://schemas.openxmlformats.org/drawingml/2006/table">
            <a:tbl>
              <a:tblPr/>
              <a:tblGrid>
                <a:gridCol w="4932814">
                  <a:extLst>
                    <a:ext uri="{9D8B030D-6E8A-4147-A177-3AD203B41FA5}">
                      <a16:colId xmlns:a16="http://schemas.microsoft.com/office/drawing/2014/main" val="1019766489"/>
                    </a:ext>
                  </a:extLst>
                </a:gridCol>
                <a:gridCol w="977380">
                  <a:extLst>
                    <a:ext uri="{9D8B030D-6E8A-4147-A177-3AD203B41FA5}">
                      <a16:colId xmlns:a16="http://schemas.microsoft.com/office/drawing/2014/main" val="1243571726"/>
                    </a:ext>
                  </a:extLst>
                </a:gridCol>
                <a:gridCol w="1397194">
                  <a:extLst>
                    <a:ext uri="{9D8B030D-6E8A-4147-A177-3AD203B41FA5}">
                      <a16:colId xmlns:a16="http://schemas.microsoft.com/office/drawing/2014/main" val="2958957764"/>
                    </a:ext>
                  </a:extLst>
                </a:gridCol>
                <a:gridCol w="636281">
                  <a:extLst>
                    <a:ext uri="{9D8B030D-6E8A-4147-A177-3AD203B41FA5}">
                      <a16:colId xmlns:a16="http://schemas.microsoft.com/office/drawing/2014/main" val="894418436"/>
                    </a:ext>
                  </a:extLst>
                </a:gridCol>
                <a:gridCol w="583803">
                  <a:extLst>
                    <a:ext uri="{9D8B030D-6E8A-4147-A177-3AD203B41FA5}">
                      <a16:colId xmlns:a16="http://schemas.microsoft.com/office/drawing/2014/main" val="3266369190"/>
                    </a:ext>
                  </a:extLst>
                </a:gridCol>
                <a:gridCol w="726309">
                  <a:extLst>
                    <a:ext uri="{9D8B030D-6E8A-4147-A177-3AD203B41FA5}">
                      <a16:colId xmlns:a16="http://schemas.microsoft.com/office/drawing/2014/main" val="448257454"/>
                    </a:ext>
                  </a:extLst>
                </a:gridCol>
                <a:gridCol w="1149735">
                  <a:extLst>
                    <a:ext uri="{9D8B030D-6E8A-4147-A177-3AD203B41FA5}">
                      <a16:colId xmlns:a16="http://schemas.microsoft.com/office/drawing/2014/main" val="2094475935"/>
                    </a:ext>
                  </a:extLst>
                </a:gridCol>
                <a:gridCol w="1653018">
                  <a:extLst>
                    <a:ext uri="{9D8B030D-6E8A-4147-A177-3AD203B41FA5}">
                      <a16:colId xmlns:a16="http://schemas.microsoft.com/office/drawing/2014/main" val="272032205"/>
                    </a:ext>
                  </a:extLst>
                </a:gridCol>
              </a:tblGrid>
              <a:tr h="193455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GB" sz="1000" b="1" i="0" u="sng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ementary Data </a:t>
                      </a:r>
                      <a:r>
                        <a:rPr lang="en-GB" sz="10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: List of antibodies</a:t>
                      </a:r>
                    </a:p>
                    <a:p>
                      <a:pPr algn="l" fontAlgn="b"/>
                      <a:endParaRPr lang="en-GB" sz="10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19" marR="5719" marT="57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5185906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centratio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nufacturer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alog No.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ecies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ality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noblotting Dilutio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mmunofluorescence Dilutio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862609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imary antibodies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6537679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athepsin Z (CTSZ)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cam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18058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bbi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25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8081548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DYKDDDDK Tag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u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Signalling  Technology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46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use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10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4368078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GAPDH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cam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9485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bbi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10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0060867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Glucagon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gma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2654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use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10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9547548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Glucagon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333333"/>
                          </a:solidFill>
                          <a:effectLst/>
                          <a:latin typeface="Arial" panose="020B0604020202020204" pitchFamily="34" charset="0"/>
                        </a:rPr>
                        <a:t>0.303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cam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92517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bbi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10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1655425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Glucagon-like peptide-1 (GLP-1)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6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cam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26278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use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5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4054563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Insulin (Autostainer link 48)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ilent 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R00261-2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uinea pig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diluted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0433928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Ki67  (Alexa Fluor ® 555)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cam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215226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bbi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25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1438442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Prolactin receptor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u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Signalling  Technology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552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bbi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5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5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9618950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Serotonin receptor 2B 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µ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nta Cruz Biotechnology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-376878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use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no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25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5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5534411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condary antibodies for immunoblotting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6288047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RDye 680 anti-Mouse IgG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-COR Biosciences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6-68072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nkey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in 100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4472220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RDye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800 anti-Rabbit IgG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-COR Biosciences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6-32213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nkey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in 100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3002388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condary antibodies for immunofluorescence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8680419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 anti-Mouse IgG (H+L) Highly Cross-Adsorbed Secondary Antibody, Alexa Fluor™ Plus 488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32723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4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3673953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 anti-Rabbit IgG (H+L) Highly Cross-Adsorbed Secondary Antibody, Alexa Fluor™ Plus 488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32731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4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076200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 anti-Mouse IgG (H+L) Highly Cross-Adsorbed Secondary Antibody, Alexa Fluor™ Plus 555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21424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4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853132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 anti-Rabbit IgG (H+L) Highly Cross-Adsorbed Secondary Antibody, Alexa Fluor™ Plus 555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32732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4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7319992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 anti-Guinea Pig IgG (H+L) Highly Cross-Adsorbed Secondary Antibody, Alexa Fluor™ Plus 647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mg/m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2145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at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clonal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in 400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9022973"/>
                  </a:ext>
                </a:extLst>
              </a:tr>
              <a:tr h="19345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ctaFluor™ Excel Amplified Anti-Rabbit IgG, DyLight™ 488 Antibody Kit </a:t>
                      </a:r>
                    </a:p>
                  </a:txBody>
                  <a:tcPr marL="34315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ctor Laboratories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K-1488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diluted</a:t>
                      </a:r>
                    </a:p>
                  </a:txBody>
                  <a:tcPr marL="5719" marR="5719" marT="57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90476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</TotalTime>
  <Words>394</Words>
  <Application>Microsoft Macintosh PowerPoint</Application>
  <PresentationFormat>Widescreen</PresentationFormat>
  <Paragraphs>1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Faheem Seedat</cp:lastModifiedBy>
  <cp:revision>1</cp:revision>
  <dcterms:created xsi:type="dcterms:W3CDTF">2024-07-22T14:39:55Z</dcterms:created>
  <dcterms:modified xsi:type="dcterms:W3CDTF">2025-06-21T07:01:13Z</dcterms:modified>
</cp:coreProperties>
</file>